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_rels/presentation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png" ContentType="image/png"/>
  <Override PartName="/ppt/media/image5.wmf" ContentType="image/x-wmf"/>
  <Override PartName="/ppt/media/image6.wmf" ContentType="image/x-wmf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</p:sldMasterIdLst>
  <p:sldIdLst>
    <p:sldId id="256" r:id="rId5"/>
    <p:sldId id="257" r:id="rId6"/>
    <p:sldId id="258" r:id="rId7"/>
    <p:sldId id="259" r:id="rId8"/>
    <p:sldId id="260" r:id="rId9"/>
    <p:sldId id="261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D2F78-AE71-4B1E-98D7-1321E2895A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B4727-5BBA-4ABC-9CF0-7B7389BA98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C9A08B-C60B-456C-A33D-400E5A561C9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D5CDDF-FA93-427C-8B59-F14BC37EFB1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21BED9D-D0B0-48D6-AB76-43C8E23033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9A56F86-E1B3-4134-817D-9E1FE7D6FA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B4534BD-074B-4D68-8A79-E2A096C704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880A49F-9AE2-4C3D-B938-AA3287968F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E3FB4CD-5747-4448-BD87-480F2DEDB4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01DC038-FB24-4888-870A-628627B568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B0584DA-4A32-406C-B7C1-16881C19EA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22A5A8-47F9-4060-AB82-1DB5342507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58BA365-3942-4D05-AAC7-C38F6D1477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1BC0B92-87FF-45D7-B714-3BA1B13CAD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665DE4A-0DF5-489F-8144-0FD41AB601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39C68DF-8C41-47B2-8422-F4D95A1DDBB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923D197-42C9-4E76-B50D-C388B4D4D6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9269F6A-13C5-48AC-A490-01F4D33EB0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891257E-A7D5-4620-AA57-C1E015087C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1118B7B-7FCA-46E5-9EF8-0A61CE3E5F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200F70A-9288-4FC7-8F49-2D8FDB4BA4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54381C5-4D0E-4DED-BF3A-32F2FDF5D7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A4C61-59EC-40DD-9AAD-E71A9FED74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69C983B-0774-46A5-8DEF-8EDEF269C9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398A87E-BC9C-41DC-8370-D7E9C117DA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22D85AB-50DA-45A3-B83C-BC6ADCA4DA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E482CC2-1F93-40BC-9031-8BC596F6B9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20BBAE8-2246-4244-9AA5-6DE5240526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0ED54A3-B387-4A0D-BE28-016A9DE319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D7A5493-70B9-4D9F-994F-F2FF5A077B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64CD1E-C67E-40A7-BD7D-BBE5545AAA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0DA084-9FA8-417B-AC1A-DB9987E522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37DD2E-85A6-4001-AA46-F61385D18C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F3B8D-FC88-4D7A-9B9D-9BCA3DB065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D4DB49-5273-4A5F-B4E9-D4A15C9A5A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C70D6C-954B-4969-B17A-36E457EF32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Date Placeholder 3"/>
          <p:cNvSpPr/>
          <p:nvPr/>
        </p:nvSpPr>
        <p:spPr>
          <a:xfrm>
            <a:off x="1905120" y="6400800"/>
            <a:ext cx="213336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44165E-E1C7-4F7C-B02E-09D5CDBE8E2D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dt" idx="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ftr" idx="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sldNum" idx="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06C9EA4-3D48-4F38-B27E-ABFAEAF7F629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3"/>
          <p:cNvSpPr>
            <a:spLocks noGrp="1"/>
          </p:cNvSpPr>
          <p:nvPr>
            <p:ph type="dt" idx="7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 type="ftr" idx="8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5"/>
          <p:cNvSpPr>
            <a:spLocks noGrp="1"/>
          </p:cNvSpPr>
          <p:nvPr>
            <p:ph type="sldNum" idx="9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121A7A-F856-43E8-A0E4-C65B96A403A7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5.wmf"/><Relationship Id="rId4" Type="http://schemas.openxmlformats.org/officeDocument/2006/relationships/image" Target="../media/image6.wmf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7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Rectangle 9"/>
          <p:cNvSpPr/>
          <p:nvPr/>
        </p:nvSpPr>
        <p:spPr>
          <a:xfrm>
            <a:off x="5638680" y="4267080"/>
            <a:ext cx="1981440" cy="152424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1"/>
          <p:cNvSpPr/>
          <p:nvPr/>
        </p:nvSpPr>
        <p:spPr>
          <a:xfrm>
            <a:off x="1224000" y="4267080"/>
            <a:ext cx="1981080" cy="152424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8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609480" y="914040"/>
            <a:ext cx="777240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anchor="ctr">
            <a:noAutofit/>
          </a:bodyPr>
          <a:p>
            <a:pPr marL="343080"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Autonomic disorders and myocardial </a:t>
            </a:r>
            <a:r>
              <a:rPr b="0" lang="en-GB" sz="1800" spc="-1" strike="noStrike" baseline="30000">
                <a:solidFill>
                  <a:srgbClr val="000000"/>
                </a:solidFill>
                <a:latin typeface="Arial"/>
              </a:rPr>
              <a:t>123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I-metaiodobenzylguanidine</a:t>
            </a:r>
            <a:br>
              <a:rPr sz="1800"/>
            </a:b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cintigraphy in</a:t>
            </a:r>
            <a:br>
              <a:rPr sz="1800"/>
            </a:b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Huntington’s disease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PlaceHolder 2"/>
          <p:cNvSpPr>
            <a:spLocks noGrp="1"/>
          </p:cNvSpPr>
          <p:nvPr>
            <p:ph type="subTitle"/>
          </p:nvPr>
        </p:nvSpPr>
        <p:spPr>
          <a:xfrm>
            <a:off x="609480" y="2209680"/>
            <a:ext cx="7772400" cy="1694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anchor="t">
            <a:noAutofit/>
          </a:bodyPr>
          <a:p>
            <a:pPr indent="0" algn="ctr">
              <a:spcBef>
                <a:spcPts val="27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ssante Roberta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, Elena Salvatore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, Carmela Nappi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, Silvio Peluso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, Giovanni De Simini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, Luigi Di Maio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, Gianluigi Rosario Palmieri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, Isabella Pia Ferrara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, Alessandro Roca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, Giuseppe De Michele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Alberto Cuocolo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, Sabina Pappata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, Anna De Rosa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27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27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 baseline="30000">
                <a:solidFill>
                  <a:srgbClr val="000000"/>
                </a:solidFill>
                <a:latin typeface="Arial"/>
              </a:rPr>
              <a:t>a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 Department of Advanced Biomedical Sciences, University Federico II, Naples, Italy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27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 baseline="30000">
                <a:solidFill>
                  <a:srgbClr val="000000"/>
                </a:solidFill>
                <a:latin typeface="Arial"/>
              </a:rPr>
              <a:t>b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Department of Neurosciences and Reproductive and Odontostomatological Sciences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, University Federico II, Naples, Italy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27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 baseline="30000">
                <a:solidFill>
                  <a:srgbClr val="000000"/>
                </a:solidFill>
                <a:latin typeface="Arial"/>
              </a:rPr>
              <a:t>c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 Institute of Biostructure and Bioimaging, National Council of Research, Naples, Italy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27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27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spcBef>
                <a:spcPts val="27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2"/>
          <p:cNvSpPr/>
          <p:nvPr/>
        </p:nvSpPr>
        <p:spPr>
          <a:xfrm>
            <a:off x="349200" y="6400800"/>
            <a:ext cx="2876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SsykbnAdvPTimes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Picture 2" descr="American Society of Nuclear Cardiology"/>
          <p:cNvPicPr/>
          <p:nvPr/>
        </p:nvPicPr>
        <p:blipFill>
          <a:blip r:embed="rId1"/>
          <a:stretch/>
        </p:blipFill>
        <p:spPr>
          <a:xfrm>
            <a:off x="6129360" y="6210360"/>
            <a:ext cx="1209600" cy="466560"/>
          </a:xfrm>
          <a:prstGeom prst="rect">
            <a:avLst/>
          </a:prstGeom>
          <a:ln w="0">
            <a:noFill/>
          </a:ln>
        </p:spPr>
      </p:pic>
      <p:pic>
        <p:nvPicPr>
          <p:cNvPr id="131" name="Picture 3" descr="C:\Users\bish01\AppData\Local\Temp\wz67be\Springer.png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4800"/>
          </a:xfrm>
          <a:prstGeom prst="rect">
            <a:avLst/>
          </a:prstGeom>
          <a:ln w="0">
            <a:noFill/>
          </a:ln>
        </p:spPr>
      </p:pic>
      <p:pic>
        <p:nvPicPr>
          <p:cNvPr id="132" name="Immagine 10" descr=""/>
          <p:cNvPicPr/>
          <p:nvPr/>
        </p:nvPicPr>
        <p:blipFill>
          <a:blip r:embed="rId3"/>
          <a:stretch/>
        </p:blipFill>
        <p:spPr>
          <a:xfrm flipH="1">
            <a:off x="6215040" y="4630680"/>
            <a:ext cx="828720" cy="797040"/>
          </a:xfrm>
          <a:prstGeom prst="rect">
            <a:avLst/>
          </a:prstGeom>
          <a:ln w="0">
            <a:noFill/>
          </a:ln>
        </p:spPr>
      </p:pic>
      <p:pic>
        <p:nvPicPr>
          <p:cNvPr id="133" name="Immagine 5" descr=""/>
          <p:cNvPicPr/>
          <p:nvPr/>
        </p:nvPicPr>
        <p:blipFill>
          <a:blip r:embed="rId4"/>
          <a:stretch/>
        </p:blipFill>
        <p:spPr>
          <a:xfrm>
            <a:off x="1308240" y="4554360"/>
            <a:ext cx="1812960" cy="873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457200" y="837720"/>
            <a:ext cx="8229600" cy="567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</a:rPr>
              <a:t>BACKGROUND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 txBox="1"/>
          <p:nvPr/>
        </p:nvSpPr>
        <p:spPr>
          <a:xfrm>
            <a:off x="457200" y="1523880"/>
            <a:ext cx="8305920" cy="4572000"/>
          </a:xfrm>
          <a:prstGeom prst="rect">
            <a:avLst/>
          </a:prstGeom>
          <a:noFill/>
          <a:ln w="9360">
            <a:solidFill>
              <a:srgbClr val="4f81bd"/>
            </a:solidFill>
            <a:miter/>
          </a:ln>
        </p:spPr>
        <p:txBody>
          <a:bodyPr anchor="t">
            <a:normAutofit/>
          </a:bodyPr>
          <a:p>
            <a:pPr>
              <a:spcBef>
                <a:spcPts val="601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- Huntington’s Disease (HD) is an autosomal dominant neurodegenerative disorder characterized by movement disorders, usually chorea, cognitive impairment, and psychiatric disturbance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- The patients may complain of autonomic disorders that often precede the onset of motor manifestations, such as gastrointestinal, urinary, cardiovascular and, in men, sexual problem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- In particular, potential cardiac manifestation of severe autonomic dysfunction, as light-headedness on standing up, tachycardia, arrhythmias, and sudden cardiac death, seems to be associated more frequently in HD than in control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01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4- Here, we aimed to investigate whether cardiac autonomic innervation assessed by 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123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-metaiodobenzylguanidine (MIBG) imaging is impaired in HD patients, in comparison with control subjects (Ctrl)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6"/>
          <p:cNvSpPr/>
          <p:nvPr/>
        </p:nvSpPr>
        <p:spPr>
          <a:xfrm>
            <a:off x="349200" y="6400800"/>
            <a:ext cx="2876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SsykbnAdvPTimes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7" name="Picture 2" descr="American Society of Nuclear Cardiology"/>
          <p:cNvPicPr/>
          <p:nvPr/>
        </p:nvPicPr>
        <p:blipFill>
          <a:blip r:embed="rId1"/>
          <a:stretch/>
        </p:blipFill>
        <p:spPr>
          <a:xfrm>
            <a:off x="6129360" y="6210360"/>
            <a:ext cx="1209600" cy="46656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3" descr="C:\Users\bish01\AppData\Local\Temp\wz67be\Springer.png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4800"/>
          </a:xfrm>
          <a:prstGeom prst="rect">
            <a:avLst/>
          </a:prstGeom>
          <a:ln w="0">
            <a:noFill/>
          </a:ln>
        </p:spPr>
      </p:pic>
      <p:sp>
        <p:nvSpPr>
          <p:cNvPr id="139" name="Rectangle 10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457200" y="837720"/>
            <a:ext cx="8229600" cy="567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</a:rPr>
              <a:t>METHODS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 txBox="1"/>
          <p:nvPr/>
        </p:nvSpPr>
        <p:spPr>
          <a:xfrm>
            <a:off x="457200" y="1523520"/>
            <a:ext cx="8305920" cy="4380120"/>
          </a:xfrm>
          <a:prstGeom prst="rect">
            <a:avLst/>
          </a:prstGeom>
          <a:noFill/>
          <a:ln w="9360">
            <a:solidFill>
              <a:srgbClr val="4f81bd"/>
            </a:solidFill>
            <a:miter/>
          </a:ln>
        </p:spPr>
        <p:txBody>
          <a:bodyPr anchor="t">
            <a:normAutofit/>
          </a:bodyPr>
          <a:p>
            <a:pPr marL="514440" indent="-514440"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AutoNum type="alphaU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tudy type: prospective observational stud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514440" indent="-514440"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AutoNum type="alphaU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tudy subjects: We included 15 HD patients (6 F and 9 M), with confirmation by genetic test, and 10 Ctrl (5 F and 5 M), comparable for ag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514440" indent="-514440"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AutoNum type="alphaU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tudy endpoints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914400" indent="-514440"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AutoNum type="alphaU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rimary end point: to 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investigate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whether cardiac autonomic innervation assessed by </a:t>
            </a: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123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-MIBG imaging is impaired in HD patients, in comparison with control subject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914400" indent="-514440"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AutoNum type="alphaU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econdary end point: to 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</a:rPr>
              <a:t>evaluate correlation between HD symptoms and cardiac innervation parameter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514440" indent="-514440">
              <a:spcBef>
                <a:spcPts val="601"/>
              </a:spcBef>
              <a:spcAft>
                <a:spcPts val="601"/>
              </a:spcAft>
              <a:buClr>
                <a:srgbClr val="000000"/>
              </a:buClr>
              <a:buFont typeface="Arial"/>
              <a:buAutoNum type="alphaU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tudy variables: MIBG cardiac imaging parameters, such as early and late H/M ratio and WR and symptoms score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6"/>
          <p:cNvSpPr/>
          <p:nvPr/>
        </p:nvSpPr>
        <p:spPr>
          <a:xfrm>
            <a:off x="349200" y="6400800"/>
            <a:ext cx="2876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SsykbnAdvPTimes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3" name="Picture 2" descr="American Society of Nuclear Cardiology"/>
          <p:cNvPicPr/>
          <p:nvPr/>
        </p:nvPicPr>
        <p:blipFill>
          <a:blip r:embed="rId1"/>
          <a:stretch/>
        </p:blipFill>
        <p:spPr>
          <a:xfrm>
            <a:off x="6129360" y="6210360"/>
            <a:ext cx="1209600" cy="466560"/>
          </a:xfrm>
          <a:prstGeom prst="rect">
            <a:avLst/>
          </a:prstGeom>
          <a:ln w="0">
            <a:noFill/>
          </a:ln>
        </p:spPr>
      </p:pic>
      <p:pic>
        <p:nvPicPr>
          <p:cNvPr id="144" name="Picture 3" descr="C:\Users\bish01\AppData\Local\Temp\wz67be\Springer.png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4800"/>
          </a:xfrm>
          <a:prstGeom prst="rect">
            <a:avLst/>
          </a:prstGeom>
          <a:ln w="0">
            <a:noFill/>
          </a:ln>
        </p:spPr>
      </p:pic>
      <p:sp>
        <p:nvSpPr>
          <p:cNvPr id="145" name="Rectangle 10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PlaceHolder 1"/>
          <p:cNvSpPr>
            <a:spLocks noGrp="1"/>
          </p:cNvSpPr>
          <p:nvPr>
            <p:ph type="title"/>
          </p:nvPr>
        </p:nvSpPr>
        <p:spPr>
          <a:xfrm>
            <a:off x="457200" y="837720"/>
            <a:ext cx="8229600" cy="567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</a:rPr>
              <a:t>RESULTS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TextBox 6"/>
          <p:cNvSpPr/>
          <p:nvPr/>
        </p:nvSpPr>
        <p:spPr>
          <a:xfrm>
            <a:off x="349200" y="6400800"/>
            <a:ext cx="2876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SsykbnAdvPTimes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8" name="Picture 2" descr="American Society of Nuclear Cardiology"/>
          <p:cNvPicPr/>
          <p:nvPr/>
        </p:nvPicPr>
        <p:blipFill>
          <a:blip r:embed="rId1"/>
          <a:stretch/>
        </p:blipFill>
        <p:spPr>
          <a:xfrm>
            <a:off x="6129360" y="6210360"/>
            <a:ext cx="1209600" cy="466560"/>
          </a:xfrm>
          <a:prstGeom prst="rect">
            <a:avLst/>
          </a:prstGeom>
          <a:ln w="0">
            <a:noFill/>
          </a:ln>
        </p:spPr>
      </p:pic>
      <p:pic>
        <p:nvPicPr>
          <p:cNvPr id="149" name="Picture 3" descr="C:\Users\bish01\AppData\Local\Temp\wz67be\Springer.png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4800"/>
          </a:xfrm>
          <a:prstGeom prst="rect">
            <a:avLst/>
          </a:prstGeom>
          <a:ln w="0">
            <a:noFill/>
          </a:ln>
        </p:spPr>
      </p:pic>
      <p:sp>
        <p:nvSpPr>
          <p:cNvPr id="150" name="Rectangle 10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CasellaDiTesto 1"/>
          <p:cNvSpPr/>
          <p:nvPr/>
        </p:nvSpPr>
        <p:spPr>
          <a:xfrm>
            <a:off x="800280" y="1523880"/>
            <a:ext cx="7543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arly H/M (A) and late H/M ratio (B) results in patients (Pt) and controls (Ctrl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2" name="Picture 5" descr=""/>
          <p:cNvPicPr/>
          <p:nvPr/>
        </p:nvPicPr>
        <p:blipFill>
          <a:blip r:embed="rId3"/>
          <a:stretch/>
        </p:blipFill>
        <p:spPr>
          <a:xfrm>
            <a:off x="25560" y="2438280"/>
            <a:ext cx="4512960" cy="3487680"/>
          </a:xfrm>
          <a:prstGeom prst="rect">
            <a:avLst/>
          </a:prstGeom>
          <a:ln w="0">
            <a:noFill/>
          </a:ln>
        </p:spPr>
      </p:pic>
      <p:pic>
        <p:nvPicPr>
          <p:cNvPr id="153" name="Picture 8" descr=""/>
          <p:cNvPicPr/>
          <p:nvPr/>
        </p:nvPicPr>
        <p:blipFill>
          <a:blip r:embed="rId4"/>
          <a:stretch/>
        </p:blipFill>
        <p:spPr>
          <a:xfrm>
            <a:off x="4457880" y="2438280"/>
            <a:ext cx="4652640" cy="3492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PlaceHolder 1"/>
          <p:cNvSpPr>
            <a:spLocks noGrp="1"/>
          </p:cNvSpPr>
          <p:nvPr>
            <p:ph type="title"/>
          </p:nvPr>
        </p:nvSpPr>
        <p:spPr>
          <a:xfrm>
            <a:off x="457200" y="837720"/>
            <a:ext cx="8229600" cy="567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</a:rPr>
              <a:t>RESULTS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TextBox 6"/>
          <p:cNvSpPr/>
          <p:nvPr/>
        </p:nvSpPr>
        <p:spPr>
          <a:xfrm>
            <a:off x="349200" y="6400800"/>
            <a:ext cx="2876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SsykbnAdvPTimes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6" name="Picture 2" descr="American Society of Nuclear Cardiology"/>
          <p:cNvPicPr/>
          <p:nvPr/>
        </p:nvPicPr>
        <p:blipFill>
          <a:blip r:embed="rId1"/>
          <a:stretch/>
        </p:blipFill>
        <p:spPr>
          <a:xfrm>
            <a:off x="6129360" y="6210360"/>
            <a:ext cx="1209600" cy="466560"/>
          </a:xfrm>
          <a:prstGeom prst="rect">
            <a:avLst/>
          </a:prstGeom>
          <a:ln w="0">
            <a:noFill/>
          </a:ln>
        </p:spPr>
      </p:pic>
      <p:pic>
        <p:nvPicPr>
          <p:cNvPr id="157" name="Picture 3" descr="C:\Users\bish01\AppData\Local\Temp\wz67be\Springer.png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4800"/>
          </a:xfrm>
          <a:prstGeom prst="rect">
            <a:avLst/>
          </a:prstGeom>
          <a:ln w="0">
            <a:noFill/>
          </a:ln>
        </p:spPr>
      </p:pic>
      <p:sp>
        <p:nvSpPr>
          <p:cNvPr id="158" name="Rectangle 10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CasellaDiTesto 1"/>
          <p:cNvSpPr/>
          <p:nvPr/>
        </p:nvSpPr>
        <p:spPr>
          <a:xfrm>
            <a:off x="647640" y="1523880"/>
            <a:ext cx="784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rrelation between SCOPA-AUT score and washout ra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0" name="Immagine 4" descr=""/>
          <p:cNvPicPr/>
          <p:nvPr/>
        </p:nvPicPr>
        <p:blipFill>
          <a:blip r:embed="rId3"/>
          <a:stretch/>
        </p:blipFill>
        <p:spPr>
          <a:xfrm>
            <a:off x="1795320" y="2030400"/>
            <a:ext cx="5553360" cy="4035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title"/>
          </p:nvPr>
        </p:nvSpPr>
        <p:spPr>
          <a:xfrm>
            <a:off x="457200" y="990720"/>
            <a:ext cx="8229600" cy="566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</a:rPr>
              <a:t>CONCLUSIONS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 txBox="1"/>
          <p:nvPr/>
        </p:nvSpPr>
        <p:spPr>
          <a:xfrm>
            <a:off x="457200" y="1792440"/>
            <a:ext cx="8305920" cy="4379760"/>
          </a:xfrm>
          <a:prstGeom prst="rect">
            <a:avLst/>
          </a:prstGeom>
          <a:noFill/>
          <a:ln w="9360">
            <a:solidFill>
              <a:srgbClr val="4f81bd"/>
            </a:solidFill>
            <a:miter/>
          </a:ln>
        </p:spPr>
        <p:txBody>
          <a:bodyPr anchor="t">
            <a:normAutofit/>
          </a:bodyPr>
          <a:p>
            <a:pPr>
              <a:spcBef>
                <a:spcPts val="1199"/>
              </a:spcBef>
              <a:spcAft>
                <a:spcPts val="18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1- Our study results indicate that myocardial postganglionic sympathetic innervation is essentially preserved or only minimally involved in HD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99"/>
              </a:spcBef>
              <a:spcAft>
                <a:spcPts val="18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2- These findings suggest that the cardiovascular dysfunction might be mainly due to the impairment of brain areas associated with the regulation and modulation of the heart function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99"/>
              </a:spcBef>
              <a:spcAft>
                <a:spcPts val="18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99"/>
              </a:spcBef>
              <a:spcAft>
                <a:spcPts val="18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99"/>
              </a:spcBef>
              <a:spcAft>
                <a:spcPts val="1800"/>
              </a:spcAft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Box 6"/>
          <p:cNvSpPr/>
          <p:nvPr/>
        </p:nvSpPr>
        <p:spPr>
          <a:xfrm>
            <a:off x="349200" y="6400800"/>
            <a:ext cx="2876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SsykbnAdvPTimes"/>
              </a:rPr>
              <a:t>Copyright  American Society of Nuclear Cardiolo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4" name="Picture 2" descr="American Society of Nuclear Cardiology"/>
          <p:cNvPicPr/>
          <p:nvPr/>
        </p:nvPicPr>
        <p:blipFill>
          <a:blip r:embed="rId1"/>
          <a:stretch/>
        </p:blipFill>
        <p:spPr>
          <a:xfrm>
            <a:off x="6129360" y="6210360"/>
            <a:ext cx="1209600" cy="466560"/>
          </a:xfrm>
          <a:prstGeom prst="rect">
            <a:avLst/>
          </a:prstGeom>
          <a:ln w="0">
            <a:noFill/>
          </a:ln>
        </p:spPr>
      </p:pic>
      <p:pic>
        <p:nvPicPr>
          <p:cNvPr id="165" name="Picture 3" descr="C:\Users\bish01\AppData\Local\Temp\wz67be\Springer.png"/>
          <p:cNvPicPr/>
          <p:nvPr/>
        </p:nvPicPr>
        <p:blipFill>
          <a:blip r:embed="rId2"/>
          <a:stretch/>
        </p:blipFill>
        <p:spPr>
          <a:xfrm>
            <a:off x="7543800" y="6264360"/>
            <a:ext cx="1255680" cy="334800"/>
          </a:xfrm>
          <a:prstGeom prst="rect">
            <a:avLst/>
          </a:prstGeom>
          <a:ln w="0">
            <a:noFill/>
          </a:ln>
        </p:spPr>
      </p:pic>
      <p:sp>
        <p:nvSpPr>
          <p:cNvPr id="166" name="Rectangle 10"/>
          <p:cNvSpPr/>
          <p:nvPr/>
        </p:nvSpPr>
        <p:spPr>
          <a:xfrm>
            <a:off x="609480" y="287280"/>
            <a:ext cx="7772400" cy="4748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 Narrow"/>
              </a:rPr>
              <a:t>Journal of Nuclear Cardiology   |   Official Journal of the American Society of Nuclear Cardi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8T21:44:13Z</dcterms:created>
  <dc:creator>Holly Auten</dc:creator>
  <dc:description/>
  <dc:language>en-US</dc:language>
  <cp:lastModifiedBy>e</cp:lastModifiedBy>
  <dcterms:modified xsi:type="dcterms:W3CDTF">2020-07-09T16:17:50Z</dcterms:modified>
  <cp:revision>131</cp:revision>
  <dc:subject/>
  <dc:title>Slide 1</dc:title>
</cp:coreProperties>
</file>